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64"/>
    <p:restoredTop sz="94631"/>
  </p:normalViewPr>
  <p:slideViewPr>
    <p:cSldViewPr snapToGrid="0" snapToObjects="1">
      <p:cViewPr>
        <p:scale>
          <a:sx n="95" d="100"/>
          <a:sy n="95" d="100"/>
        </p:scale>
        <p:origin x="2008" y="-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C4C760-06A5-DE44-B0B9-C7681A671F20}" type="datetimeFigureOut">
              <a:rPr lang="en-US" smtClean="0"/>
              <a:t>3/2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D3C8F-4F3F-1D45-9F41-19937EDA4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478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844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91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75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00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371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14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654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515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844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94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436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99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F067601-6F2E-5A46-9F19-B9262DD166F8}"/>
              </a:ext>
            </a:extLst>
          </p:cNvPr>
          <p:cNvSpPr txBox="1"/>
          <p:nvPr/>
        </p:nvSpPr>
        <p:spPr>
          <a:xfrm>
            <a:off x="1518988" y="5328740"/>
            <a:ext cx="4005327" cy="101566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Pol II-catalyzed transcription depending on the TFIIIA-7ZF/template ratio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n vitro transcription products detected by the (+)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iboprobe;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emplates detected by the (-)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iboprobe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, circular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l, linear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B0587A-2970-BC45-A39C-07725CDC30EA}"/>
              </a:ext>
            </a:extLst>
          </p:cNvPr>
          <p:cNvSpPr txBox="1"/>
          <p:nvPr/>
        </p:nvSpPr>
        <p:spPr>
          <a:xfrm>
            <a:off x="2354976" y="388479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33FC86-61D3-3446-99FE-C2ACE139CA6E}"/>
              </a:ext>
            </a:extLst>
          </p:cNvPr>
          <p:cNvSpPr txBox="1"/>
          <p:nvPr/>
        </p:nvSpPr>
        <p:spPr>
          <a:xfrm>
            <a:off x="2382905" y="4159310"/>
            <a:ext cx="218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1B9E13-BEB3-994F-B600-986C78E4BCAC}"/>
              </a:ext>
            </a:extLst>
          </p:cNvPr>
          <p:cNvSpPr txBox="1"/>
          <p:nvPr/>
        </p:nvSpPr>
        <p:spPr>
          <a:xfrm>
            <a:off x="2363585" y="257882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DB0644E-7630-2E47-B5BD-BD9A62F8F1F3}"/>
              </a:ext>
            </a:extLst>
          </p:cNvPr>
          <p:cNvCxnSpPr>
            <a:cxnSpLocks/>
          </p:cNvCxnSpPr>
          <p:nvPr/>
        </p:nvCxnSpPr>
        <p:spPr>
          <a:xfrm>
            <a:off x="2552882" y="4038303"/>
            <a:ext cx="483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D3CC38D-31C1-0541-9F8E-A0E4E37BFD9C}"/>
              </a:ext>
            </a:extLst>
          </p:cNvPr>
          <p:cNvCxnSpPr>
            <a:cxnSpLocks/>
          </p:cNvCxnSpPr>
          <p:nvPr/>
        </p:nvCxnSpPr>
        <p:spPr>
          <a:xfrm>
            <a:off x="2552882" y="4290934"/>
            <a:ext cx="483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7B55A35-37FE-9344-8904-6FCEC82C67A3}"/>
              </a:ext>
            </a:extLst>
          </p:cNvPr>
          <p:cNvCxnSpPr>
            <a:cxnSpLocks/>
          </p:cNvCxnSpPr>
          <p:nvPr/>
        </p:nvCxnSpPr>
        <p:spPr>
          <a:xfrm>
            <a:off x="2555910" y="2741499"/>
            <a:ext cx="483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EED3CA2-FE91-4546-B989-AD10A03C3B70}"/>
              </a:ext>
            </a:extLst>
          </p:cNvPr>
          <p:cNvSpPr txBox="1"/>
          <p:nvPr/>
        </p:nvSpPr>
        <p:spPr>
          <a:xfrm>
            <a:off x="1983888" y="20526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5C0FF1C-6127-7E41-AD33-A7C2456ABCD7}"/>
              </a:ext>
            </a:extLst>
          </p:cNvPr>
          <p:cNvSpPr txBox="1"/>
          <p:nvPr/>
        </p:nvSpPr>
        <p:spPr>
          <a:xfrm>
            <a:off x="1974067" y="34572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7AEE163-A912-E844-8FA8-F4DF6C969F62}"/>
              </a:ext>
            </a:extLst>
          </p:cNvPr>
          <p:cNvSpPr txBox="1"/>
          <p:nvPr/>
        </p:nvSpPr>
        <p:spPr>
          <a:xfrm>
            <a:off x="3849199" y="2726984"/>
            <a:ext cx="93647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(-)-</a:t>
            </a:r>
            <a:r>
              <a:rPr lang="en-US" sz="13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DF19170-7AB5-BF4E-8CE2-0B32B5156954}"/>
              </a:ext>
            </a:extLst>
          </p:cNvPr>
          <p:cNvSpPr txBox="1"/>
          <p:nvPr/>
        </p:nvSpPr>
        <p:spPr>
          <a:xfrm>
            <a:off x="3847692" y="4120562"/>
            <a:ext cx="97815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(+)-</a:t>
            </a:r>
            <a:r>
              <a:rPr lang="en-US" sz="13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6FD66A0-0CAB-0C4C-BE3B-91FF9C3ADA10}"/>
              </a:ext>
            </a:extLst>
          </p:cNvPr>
          <p:cNvSpPr txBox="1"/>
          <p:nvPr/>
        </p:nvSpPr>
        <p:spPr>
          <a:xfrm>
            <a:off x="2623502" y="2293583"/>
            <a:ext cx="2531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   100    160   240  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bTFIIIA-7ZF (ng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4D26D39-8CD8-4746-8787-16DF7BC10BDF}"/>
              </a:ext>
            </a:extLst>
          </p:cNvPr>
          <p:cNvSpPr txBox="1"/>
          <p:nvPr/>
        </p:nvSpPr>
        <p:spPr>
          <a:xfrm>
            <a:off x="2641424" y="3613874"/>
            <a:ext cx="2531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    100   160   240 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bTFIIIA-7ZF (ng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BF3295-6705-7F4D-A99F-C53964C4BF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7000" contrast="37000"/>
                    </a14:imgEffect>
                  </a14:imgLayer>
                </a14:imgProps>
              </a:ext>
            </a:extLst>
          </a:blip>
          <a:srcRect/>
          <a:stretch/>
        </p:blipFill>
        <p:spPr>
          <a:xfrm flipH="1">
            <a:off x="2618093" y="3832161"/>
            <a:ext cx="1233410" cy="638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4CD0DA2-BA70-3544-8336-19E902C800B3}"/>
              </a:ext>
            </a:extLst>
          </p:cNvPr>
          <p:cNvSpPr txBox="1"/>
          <p:nvPr/>
        </p:nvSpPr>
        <p:spPr>
          <a:xfrm>
            <a:off x="2383873" y="2894523"/>
            <a:ext cx="218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B396B5A8-2DDC-D342-A885-8AF5229112CD}"/>
              </a:ext>
            </a:extLst>
          </p:cNvPr>
          <p:cNvCxnSpPr>
            <a:cxnSpLocks/>
          </p:cNvCxnSpPr>
          <p:nvPr/>
        </p:nvCxnSpPr>
        <p:spPr>
          <a:xfrm>
            <a:off x="2553850" y="3026147"/>
            <a:ext cx="483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>
            <a:extLst>
              <a:ext uri="{FF2B5EF4-FFF2-40B4-BE49-F238E27FC236}">
                <a16:creationId xmlns:a16="http://schemas.microsoft.com/office/drawing/2014/main" id="{FB8B8463-B3C4-E84E-8298-E0D40A766D4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616584" y="2515067"/>
            <a:ext cx="1231107" cy="6394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FB48502-B18B-1148-BA66-F362B4B8280C}"/>
              </a:ext>
            </a:extLst>
          </p:cNvPr>
          <p:cNvCxnSpPr>
            <a:cxnSpLocks/>
          </p:cNvCxnSpPr>
          <p:nvPr/>
        </p:nvCxnSpPr>
        <p:spPr>
          <a:xfrm>
            <a:off x="2354976" y="2880097"/>
            <a:ext cx="2472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666578D-C428-0348-BC70-BA26379B7269}"/>
              </a:ext>
            </a:extLst>
          </p:cNvPr>
          <p:cNvCxnSpPr>
            <a:cxnSpLocks/>
          </p:cNvCxnSpPr>
          <p:nvPr/>
        </p:nvCxnSpPr>
        <p:spPr>
          <a:xfrm>
            <a:off x="2489386" y="2819772"/>
            <a:ext cx="1114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C95A768-EBCA-E041-9210-B9728A4BE3D0}"/>
              </a:ext>
            </a:extLst>
          </p:cNvPr>
          <p:cNvCxnSpPr>
            <a:cxnSpLocks/>
          </p:cNvCxnSpPr>
          <p:nvPr/>
        </p:nvCxnSpPr>
        <p:spPr>
          <a:xfrm>
            <a:off x="2490808" y="2931269"/>
            <a:ext cx="1114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3111DEE-24F3-4941-A13B-86DD60EA1BEF}"/>
              </a:ext>
            </a:extLst>
          </p:cNvPr>
          <p:cNvCxnSpPr>
            <a:cxnSpLocks/>
          </p:cNvCxnSpPr>
          <p:nvPr/>
        </p:nvCxnSpPr>
        <p:spPr>
          <a:xfrm flipV="1">
            <a:off x="2354976" y="2931269"/>
            <a:ext cx="139385" cy="310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BAC6ED7-F7BD-3048-8739-606AF8A67622}"/>
              </a:ext>
            </a:extLst>
          </p:cNvPr>
          <p:cNvCxnSpPr>
            <a:cxnSpLocks/>
          </p:cNvCxnSpPr>
          <p:nvPr/>
        </p:nvCxnSpPr>
        <p:spPr>
          <a:xfrm>
            <a:off x="2362834" y="2776804"/>
            <a:ext cx="126122" cy="427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15329D08-7A4B-2D48-8C58-BE7CEEC75058}"/>
              </a:ext>
            </a:extLst>
          </p:cNvPr>
          <p:cNvSpPr txBox="1"/>
          <p:nvPr/>
        </p:nvSpPr>
        <p:spPr>
          <a:xfrm>
            <a:off x="1983212" y="2643960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523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8FCCB0A-A2D8-A649-AC31-857D93E4A195}"/>
              </a:ext>
            </a:extLst>
          </p:cNvPr>
          <p:cNvSpPr txBox="1"/>
          <p:nvPr/>
        </p:nvSpPr>
        <p:spPr>
          <a:xfrm>
            <a:off x="1979879" y="2762850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7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FC0CD63-0A74-184C-8FD7-BC57D8F16175}"/>
              </a:ext>
            </a:extLst>
          </p:cNvPr>
          <p:cNvSpPr txBox="1"/>
          <p:nvPr/>
        </p:nvSpPr>
        <p:spPr>
          <a:xfrm>
            <a:off x="1979879" y="2877488"/>
            <a:ext cx="4347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25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632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</TotalTime>
  <Words>83</Words>
  <Application>Microsoft Macintosh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用户</dc:creator>
  <cp:lastModifiedBy>Microsoft Office 用户</cp:lastModifiedBy>
  <cp:revision>72</cp:revision>
  <cp:lastPrinted>2020-02-19T01:41:33Z</cp:lastPrinted>
  <dcterms:created xsi:type="dcterms:W3CDTF">2020-02-05T03:48:30Z</dcterms:created>
  <dcterms:modified xsi:type="dcterms:W3CDTF">2020-03-21T01:46:50Z</dcterms:modified>
</cp:coreProperties>
</file>